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99200" cy="10234800"/>
          </a:xfrm>
          <a:prstGeom prst="rect">
            <a:avLst/>
          </a:prstGeom>
          <a:solidFill>
            <a:srgbClr val="ffffff"/>
          </a:solidFill>
          <a:ln w="9360">
            <a:noFill/>
          </a:ln>
        </p:spPr>
        <p:txBody>
          <a:bodyPr lIns="90000" rIns="90000" tIns="45000" bIns="45000" anchor="ctr" anchorCtr="1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0" y="0"/>
            <a:ext cx="7099200" cy="10234440"/>
          </a:xfrm>
          <a:custGeom>
            <a:avLst/>
            <a:gdLst>
              <a:gd name="textAreaLeft" fmla="*/ 360 w 7099200"/>
              <a:gd name="textAreaRight" fmla="*/ 7098840 w 7099200"/>
              <a:gd name="textAreaTop" fmla="*/ 360 h 10234440"/>
              <a:gd name="textAreaBottom" fmla="*/ 10234080 h 10234440"/>
            </a:gdLst>
            <a:ahLst/>
            <a:rect l="textAreaLeft" t="textAreaTop" r="textAreaRight" b="textAreaBottom"/>
            <a:pathLst>
              <a:path w="21600" h="31139">
                <a:moveTo>
                  <a:pt x="4" y="0"/>
                </a:moveTo>
                <a:arcTo wR="4" hR="4" stAng="16200000" swAng="-5400000"/>
                <a:lnTo>
                  <a:pt x="0" y="31135"/>
                </a:lnTo>
                <a:arcTo wR="4" hR="4" stAng="10800000" swAng="-5400000"/>
                <a:lnTo>
                  <a:pt x="21596" y="3113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0" y="0"/>
            <a:ext cx="7099200" cy="10234440"/>
          </a:xfrm>
          <a:custGeom>
            <a:avLst/>
            <a:gdLst>
              <a:gd name="textAreaLeft" fmla="*/ 360 w 7099200"/>
              <a:gd name="textAreaRight" fmla="*/ 7098840 w 7099200"/>
              <a:gd name="textAreaTop" fmla="*/ 360 h 10234440"/>
              <a:gd name="textAreaBottom" fmla="*/ 10234080 h 10234440"/>
            </a:gdLst>
            <a:ahLst/>
            <a:rect l="textAreaLeft" t="textAreaTop" r="textAreaRight" b="textAreaBottom"/>
            <a:pathLst>
              <a:path w="21600" h="31139">
                <a:moveTo>
                  <a:pt x="4" y="0"/>
                </a:moveTo>
                <a:arcTo wR="4" hR="4" stAng="16200000" swAng="-5400000"/>
                <a:lnTo>
                  <a:pt x="0" y="31135"/>
                </a:lnTo>
                <a:arcTo wR="4" hR="4" stAng="10800000" swAng="-5400000"/>
                <a:lnTo>
                  <a:pt x="21596" y="3113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1"/>
          <p:cNvSpPr>
            <a:spLocks noGrp="1"/>
          </p:cNvSpPr>
          <p:nvPr>
            <p:ph type="sldImg"/>
          </p:nvPr>
        </p:nvSpPr>
        <p:spPr>
          <a:xfrm>
            <a:off x="-11798280" y="-11796840"/>
            <a:ext cx="11795040" cy="12571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body"/>
          </p:nvPr>
        </p:nvSpPr>
        <p:spPr>
          <a:xfrm>
            <a:off x="709560" y="4860720"/>
            <a:ext cx="5673600" cy="4600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7" name=""/>
          <p:cNvSpPr/>
          <p:nvPr/>
        </p:nvSpPr>
        <p:spPr>
          <a:xfrm>
            <a:off x="2219400" y="777960"/>
            <a:ext cx="2662200" cy="38368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PlaceHolder 1"/>
          <p:cNvSpPr>
            <a:spLocks noGrp="1"/>
          </p:cNvSpPr>
          <p:nvPr>
            <p:ph type="body"/>
          </p:nvPr>
        </p:nvSpPr>
        <p:spPr>
          <a:xfrm>
            <a:off x="709200" y="4860720"/>
            <a:ext cx="5675400" cy="4601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5C4E73-DAAF-410F-96B0-5A1FC1AAC5F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840"/>
            <a:ext cx="6167160" cy="151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81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720"/>
            <a:ext cx="6167160" cy="2875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1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3000"/>
            <a:ext cx="6167160" cy="2875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1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962AC8-CBC9-404E-ABD4-37E60C89A2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840"/>
            <a:ext cx="6167160" cy="151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81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720"/>
            <a:ext cx="3009240" cy="2875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1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800" y="2133720"/>
            <a:ext cx="3009240" cy="2875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1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3000"/>
            <a:ext cx="3009240" cy="2875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1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800" y="5283000"/>
            <a:ext cx="3009240" cy="2875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1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9FFB3E-EA81-41E1-8E37-5A0E05F0F81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840"/>
            <a:ext cx="6167160" cy="151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81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720"/>
            <a:ext cx="1985760" cy="2875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1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8200" y="2133720"/>
            <a:ext cx="1985760" cy="2875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1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3680" y="2133720"/>
            <a:ext cx="1985760" cy="2875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1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3000"/>
            <a:ext cx="1985760" cy="2875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1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8200" y="5283000"/>
            <a:ext cx="1985760" cy="2875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1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3680" y="5283000"/>
            <a:ext cx="1985760" cy="2875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1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513F65-3C34-4C02-AD15-BF5CBF19F61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840"/>
            <a:ext cx="6167160" cy="151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81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720"/>
            <a:ext cx="6167160" cy="6029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81000"/>
              </a:lnSpc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05D8E0-801F-4721-95BA-BE9E9B7D48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840"/>
            <a:ext cx="6167160" cy="151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81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720"/>
            <a:ext cx="6167160" cy="602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1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26A566-0A03-4FD8-8253-DB83DE9CA3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840"/>
            <a:ext cx="6167160" cy="151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81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720"/>
            <a:ext cx="3009240" cy="602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1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800" y="2133720"/>
            <a:ext cx="3009240" cy="602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1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2429C1-B58D-4939-8C04-E448DC8EB3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840"/>
            <a:ext cx="6167160" cy="151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81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C79448-AC4A-491D-83FE-BD3597913B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840"/>
            <a:ext cx="6167160" cy="7043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81000"/>
              </a:lnSpc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740C9D-5119-4AC6-B243-BEAD06748E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840"/>
            <a:ext cx="6167160" cy="151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81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720"/>
            <a:ext cx="3009240" cy="2875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1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800" y="2133720"/>
            <a:ext cx="3009240" cy="602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1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3000"/>
            <a:ext cx="3009240" cy="2875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1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889FE8-3130-4D67-AD39-137B1BB9E0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840"/>
            <a:ext cx="6167160" cy="151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81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720"/>
            <a:ext cx="3009240" cy="602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1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800" y="2133720"/>
            <a:ext cx="3009240" cy="2875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1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800" y="5283000"/>
            <a:ext cx="3009240" cy="2875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1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7174D6-4098-4161-BB56-4D04233995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840"/>
            <a:ext cx="6167160" cy="151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81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720"/>
            <a:ext cx="3009240" cy="2875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1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800" y="2133720"/>
            <a:ext cx="3009240" cy="2875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1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3000"/>
            <a:ext cx="6167160" cy="2875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1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015616-8F78-45F5-ACD8-D750122272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840"/>
            <a:ext cx="6167160" cy="151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81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720"/>
            <a:ext cx="6167160" cy="602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38040" indent="-338040">
              <a:lnSpc>
                <a:spcPct val="81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8360" indent="-281160">
              <a:lnSpc>
                <a:spcPct val="81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81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81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81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81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81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080"/>
            <a:ext cx="1595160" cy="63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2880" y="8326080"/>
            <a:ext cx="2166840" cy="63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080"/>
            <a:ext cx="1595160" cy="63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E849C96C-98E7-4677-A3BD-34FC5AA69093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"/>
          <p:cNvSpPr/>
          <p:nvPr/>
        </p:nvSpPr>
        <p:spPr>
          <a:xfrm>
            <a:off x="1449360" y="8134200"/>
            <a:ext cx="28796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397160" y="6494400"/>
            <a:ext cx="10411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414440" y="6251400"/>
            <a:ext cx="41752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414440" y="6013440"/>
            <a:ext cx="41752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414440" y="5522760"/>
            <a:ext cx="41752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219480" y="6499080"/>
            <a:ext cx="23907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414440" y="5767560"/>
            <a:ext cx="41752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414440" y="5278320"/>
            <a:ext cx="41752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H="1">
            <a:off x="4931640" y="541188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259080" y="2166840"/>
            <a:ext cx="1173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692280" y="485784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692280" y="82872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690480" y="2782800"/>
            <a:ext cx="3351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691560" y="671184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691560" y="1317600"/>
            <a:ext cx="56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Sakl0B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692280" y="1808280"/>
            <a:ext cx="549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Klth0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552680" y="1927080"/>
            <a:ext cx="28796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flipH="1">
            <a:off x="1599480" y="181944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9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flipH="1">
            <a:off x="1924200" y="1819440"/>
            <a:ext cx="258480" cy="203040"/>
          </a:xfrm>
          <a:prstGeom prst="rightArrow">
            <a:avLst>
              <a:gd name="adj1" fmla="val 50000"/>
              <a:gd name="adj2" fmla="val 31826"/>
            </a:avLst>
          </a:prstGeom>
          <a:solidFill>
            <a:srgbClr val="87a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flipH="1">
            <a:off x="2307600" y="181944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ff66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flipH="1">
            <a:off x="2677320" y="181944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flipH="1">
            <a:off x="4016520" y="1819440"/>
            <a:ext cx="258480" cy="203040"/>
          </a:xfrm>
          <a:prstGeom prst="rightArrow">
            <a:avLst>
              <a:gd name="adj1" fmla="val 50000"/>
              <a:gd name="adj2" fmla="val 31826"/>
            </a:avLst>
          </a:prstGeom>
          <a:solidFill>
            <a:srgbClr val="00c7c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flipH="1">
            <a:off x="3358440" y="181944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3713040" y="181944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544400" y="18367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531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857960" y="18367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5334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283560" y="18367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540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2245320" y="18367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536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606400" y="18367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537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3639240" y="18367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542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943800" y="18367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5444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691560" y="1073160"/>
            <a:ext cx="56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Zyro0F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2720160" y="2043000"/>
            <a:ext cx="587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Ergo0B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1552680" y="1436760"/>
            <a:ext cx="28796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 flipH="1">
            <a:off x="1599480" y="132876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9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flipH="1">
            <a:off x="1923480" y="132876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87a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flipH="1">
            <a:off x="2309040" y="132876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66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flipH="1">
            <a:off x="2679120" y="132876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 flipH="1">
            <a:off x="4015800" y="132876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00c7c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flipH="1">
            <a:off x="3358440" y="132876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3714840" y="132876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2990880" y="1328760"/>
            <a:ext cx="333360" cy="203040"/>
          </a:xfrm>
          <a:prstGeom prst="rightArrow">
            <a:avLst>
              <a:gd name="adj1" fmla="val 50000"/>
              <a:gd name="adj2" fmla="val 41046"/>
            </a:avLst>
          </a:prstGeom>
          <a:solidFill>
            <a:srgbClr val="ffffff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1548360" y="134604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585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1869840" y="134604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5874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2251800" y="134604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589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2612160" y="134604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591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3294720" y="134604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596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2924280" y="1333440"/>
            <a:ext cx="4413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600" spc="-1" strike="noStrike">
                <a:solidFill>
                  <a:srgbClr val="ff0000"/>
                </a:solidFill>
                <a:latin typeface="Arial"/>
                <a:ea typeface="Arial"/>
              </a:rPr>
              <a:t>05940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3645360" y="134604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5984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3951720" y="134604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600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4384800" y="1438200"/>
            <a:ext cx="63360" cy="18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691560" y="1562040"/>
            <a:ext cx="671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Klwa.s3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 flipH="1">
            <a:off x="4016520" y="2063880"/>
            <a:ext cx="258480" cy="203040"/>
          </a:xfrm>
          <a:prstGeom prst="rightArrow">
            <a:avLst>
              <a:gd name="adj1" fmla="val 50000"/>
              <a:gd name="adj2" fmla="val 31826"/>
            </a:avLst>
          </a:prstGeom>
          <a:solidFill>
            <a:srgbClr val="00c7c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 flipH="1">
            <a:off x="3358440" y="206388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3713040" y="206388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3292920" y="20811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822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3639240" y="20811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825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3944880" y="20811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827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690840" y="2460600"/>
            <a:ext cx="525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Klla0F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1552680" y="2579760"/>
            <a:ext cx="28796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 flipH="1">
            <a:off x="1599480" y="247176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9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 flipH="1">
            <a:off x="1924200" y="2471760"/>
            <a:ext cx="258480" cy="203040"/>
          </a:xfrm>
          <a:prstGeom prst="rightArrow">
            <a:avLst>
              <a:gd name="adj1" fmla="val 50000"/>
              <a:gd name="adj2" fmla="val 31826"/>
            </a:avLst>
          </a:prstGeom>
          <a:solidFill>
            <a:srgbClr val="87a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 flipH="1">
            <a:off x="2307600" y="247176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ff66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 flipH="1">
            <a:off x="2677320" y="247176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 flipH="1">
            <a:off x="4016520" y="2471760"/>
            <a:ext cx="258480" cy="203040"/>
          </a:xfrm>
          <a:prstGeom prst="rightArrow">
            <a:avLst>
              <a:gd name="adj1" fmla="val 50000"/>
              <a:gd name="adj2" fmla="val 31826"/>
            </a:avLst>
          </a:prstGeom>
          <a:solidFill>
            <a:srgbClr val="00c7c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 flipH="1">
            <a:off x="3358440" y="247176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3713040" y="247176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1545120" y="248904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8591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1858680" y="248904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8613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3292920" y="248904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8679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2246040" y="248904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8635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2611080" y="248904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8657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3639960" y="248904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8701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3943800" y="248904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8723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1552680" y="1681200"/>
            <a:ext cx="28796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 flipH="1">
            <a:off x="1599480" y="157320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9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 flipH="1">
            <a:off x="1924200" y="1573200"/>
            <a:ext cx="258480" cy="203040"/>
          </a:xfrm>
          <a:prstGeom prst="rightArrow">
            <a:avLst>
              <a:gd name="adj1" fmla="val 50000"/>
              <a:gd name="adj2" fmla="val 31826"/>
            </a:avLst>
          </a:prstGeom>
          <a:solidFill>
            <a:srgbClr val="87a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 flipH="1">
            <a:off x="2307600" y="157320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ff66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 flipH="1">
            <a:off x="2677320" y="157320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 flipH="1">
            <a:off x="4016520" y="1573200"/>
            <a:ext cx="258480" cy="203040"/>
          </a:xfrm>
          <a:prstGeom prst="rightArrow">
            <a:avLst>
              <a:gd name="adj1" fmla="val 50000"/>
              <a:gd name="adj2" fmla="val 31826"/>
            </a:avLst>
          </a:prstGeom>
          <a:solidFill>
            <a:srgbClr val="00c7c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 flipH="1">
            <a:off x="3358440" y="157320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3713040" y="157320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1545840" y="1590840"/>
            <a:ext cx="356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589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1857960" y="1590840"/>
            <a:ext cx="356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589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3284280" y="1590840"/>
            <a:ext cx="356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588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2246040" y="1590840"/>
            <a:ext cx="356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589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2625480" y="1590840"/>
            <a:ext cx="356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588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3639960" y="1590840"/>
            <a:ext cx="356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587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3957480" y="1590840"/>
            <a:ext cx="356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587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1552680" y="1192320"/>
            <a:ext cx="28796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 flipH="1">
            <a:off x="1599480" y="109692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ff9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 flipH="1">
            <a:off x="1924920" y="109692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87a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 flipH="1">
            <a:off x="2309040" y="1096920"/>
            <a:ext cx="260280" cy="203400"/>
          </a:xfrm>
          <a:prstGeom prst="rightArrow">
            <a:avLst>
              <a:gd name="adj1" fmla="val 50000"/>
              <a:gd name="adj2" fmla="val 31991"/>
            </a:avLst>
          </a:prstGeom>
          <a:solidFill>
            <a:srgbClr val="ff66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 flipH="1">
            <a:off x="2679120" y="1096920"/>
            <a:ext cx="260280" cy="203400"/>
          </a:xfrm>
          <a:prstGeom prst="rightArrow">
            <a:avLst>
              <a:gd name="adj1" fmla="val 50000"/>
              <a:gd name="adj2" fmla="val 31991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 flipH="1">
            <a:off x="4017240" y="109692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00c7c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 flipH="1">
            <a:off x="3358440" y="109692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1540440" y="11080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249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1853280" y="11080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251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3291480" y="11080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2584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2241360" y="11080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254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2601000" y="11080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256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3951000" y="11080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260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691920" y="2212920"/>
            <a:ext cx="575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Ergo0F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1555920" y="2332080"/>
            <a:ext cx="14364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 flipH="1">
            <a:off x="1602720" y="222408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9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 flipH="1">
            <a:off x="1924920" y="222408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87a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 flipH="1">
            <a:off x="2310840" y="222408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ff66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 flipH="1">
            <a:off x="2680560" y="222408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1522800" y="22417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331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1861920" y="22417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333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2248200" y="22417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3354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2608560" y="22417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337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4384800" y="2165400"/>
            <a:ext cx="6336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4384800" y="1928880"/>
            <a:ext cx="6336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4384800" y="2573280"/>
            <a:ext cx="63360" cy="18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4384800" y="1190520"/>
            <a:ext cx="63360" cy="18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3000240" y="2330280"/>
            <a:ext cx="63720" cy="18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 flipH="1">
            <a:off x="1472760" y="1681200"/>
            <a:ext cx="7308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1681200" y="4381560"/>
            <a:ext cx="30481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690840" y="3344760"/>
            <a:ext cx="569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Sakl0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691560" y="3854520"/>
            <a:ext cx="555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Klth0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1384200" y="3973680"/>
            <a:ext cx="45705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 flipH="1">
            <a:off x="2436120" y="386568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ffc9e4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2806560" y="3865680"/>
            <a:ext cx="260640" cy="203040"/>
          </a:xfrm>
          <a:prstGeom prst="rightArrow">
            <a:avLst>
              <a:gd name="adj1" fmla="val 50000"/>
              <a:gd name="adj2" fmla="val 32092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4397400" y="386568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e3dcb7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3487680" y="386568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dc4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4094280" y="3865680"/>
            <a:ext cx="258480" cy="203040"/>
          </a:xfrm>
          <a:prstGeom prst="rightArrow">
            <a:avLst>
              <a:gd name="adj1" fmla="val 50000"/>
              <a:gd name="adj2" fmla="val 31826"/>
            </a:avLst>
          </a:prstGeom>
          <a:solidFill>
            <a:srgbClr val="f0c8b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5626080" y="387036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00d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 flipH="1">
            <a:off x="5299920" y="387036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 flipH="1">
            <a:off x="5543640" y="38815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49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 flipH="1">
            <a:off x="5236560" y="38815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52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3412080" y="38829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63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2373840" y="38829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674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2734920" y="38829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65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4020840" y="3882960"/>
            <a:ext cx="356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60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4327200" y="38829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58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691920" y="3100320"/>
            <a:ext cx="575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Zyro0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1681200" y="3463920"/>
            <a:ext cx="45702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 flipH="1">
            <a:off x="1730520" y="3355920"/>
            <a:ext cx="258480" cy="203400"/>
          </a:xfrm>
          <a:prstGeom prst="rightArrow">
            <a:avLst>
              <a:gd name="adj1" fmla="val 50000"/>
              <a:gd name="adj2" fmla="val 31770"/>
            </a:avLst>
          </a:prstGeom>
          <a:solidFill>
            <a:srgbClr val="00d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2052720" y="3355920"/>
            <a:ext cx="260280" cy="203400"/>
          </a:xfrm>
          <a:prstGeom prst="rightArrow">
            <a:avLst>
              <a:gd name="adj1" fmla="val 50000"/>
              <a:gd name="adj2" fmla="val 31991"/>
            </a:avLst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 flipH="1">
            <a:off x="2436120" y="335592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ffc9e4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2808360" y="3355920"/>
            <a:ext cx="260280" cy="203400"/>
          </a:xfrm>
          <a:prstGeom prst="rightArrow">
            <a:avLst>
              <a:gd name="adj1" fmla="val 50000"/>
              <a:gd name="adj2" fmla="val 31991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4397400" y="3355920"/>
            <a:ext cx="260280" cy="203400"/>
          </a:xfrm>
          <a:prstGeom prst="rightArrow">
            <a:avLst>
              <a:gd name="adj1" fmla="val 50000"/>
              <a:gd name="adj2" fmla="val 31991"/>
            </a:avLst>
          </a:prstGeom>
          <a:solidFill>
            <a:srgbClr val="e3dcb7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3489480" y="3355920"/>
            <a:ext cx="258480" cy="203400"/>
          </a:xfrm>
          <a:prstGeom prst="rightArrow">
            <a:avLst>
              <a:gd name="adj1" fmla="val 50000"/>
              <a:gd name="adj2" fmla="val 31770"/>
            </a:avLst>
          </a:prstGeom>
          <a:solidFill>
            <a:srgbClr val="ffdc4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4095720" y="335592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f0c8b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 flipH="1">
            <a:off x="3111480" y="3355920"/>
            <a:ext cx="333360" cy="203400"/>
          </a:xfrm>
          <a:prstGeom prst="rightArrow">
            <a:avLst>
              <a:gd name="adj1" fmla="val 50000"/>
              <a:gd name="adj2" fmla="val 40973"/>
            </a:avLst>
          </a:prstGeom>
          <a:solidFill>
            <a:srgbClr val="ffffff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1667520" y="33735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459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1998360" y="33735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462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2381040" y="33735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464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2740320" y="33735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4664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3423960" y="33735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470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3066120" y="3360600"/>
            <a:ext cx="4413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600" spc="-1" strike="noStrike">
                <a:solidFill>
                  <a:srgbClr val="ff0000"/>
                </a:solidFill>
                <a:latin typeface="Arial"/>
                <a:ea typeface="Arial"/>
              </a:rPr>
              <a:t>04686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4013640" y="33735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473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4322520" y="33735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475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6261120" y="3460680"/>
            <a:ext cx="63360" cy="18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690840" y="3608280"/>
            <a:ext cx="671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Klwa.s4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4397400" y="428004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e3dcb7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3487680" y="428004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dc4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4094280" y="4280040"/>
            <a:ext cx="258480" cy="203040"/>
          </a:xfrm>
          <a:prstGeom prst="rightArrow">
            <a:avLst>
              <a:gd name="adj1" fmla="val 50000"/>
              <a:gd name="adj2" fmla="val 31826"/>
            </a:avLst>
          </a:prstGeom>
          <a:solidFill>
            <a:srgbClr val="f0c8b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3421800" y="42973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772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4020120" y="42973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776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4327920" y="42973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778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692640" y="4502160"/>
            <a:ext cx="537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Klla0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1681200" y="4621320"/>
            <a:ext cx="45957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 flipH="1">
            <a:off x="1728000" y="451332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00d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2052720" y="451332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 flipH="1">
            <a:off x="2436120" y="451332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ffc9e4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2806560" y="4513320"/>
            <a:ext cx="260640" cy="203040"/>
          </a:xfrm>
          <a:prstGeom prst="rightArrow">
            <a:avLst>
              <a:gd name="adj1" fmla="val 50000"/>
              <a:gd name="adj2" fmla="val 32092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4397400" y="451332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e3dcb7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3487680" y="451332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dc4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4094280" y="4513320"/>
            <a:ext cx="258480" cy="203040"/>
          </a:xfrm>
          <a:prstGeom prst="rightArrow">
            <a:avLst>
              <a:gd name="adj1" fmla="val 50000"/>
              <a:gd name="adj2" fmla="val 31826"/>
            </a:avLst>
          </a:prstGeom>
          <a:solidFill>
            <a:srgbClr val="f0c8b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1667520" y="453060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1991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1973880" y="453060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1969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3408120" y="453060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1903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2374560" y="453060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1947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2734200" y="453060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1925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4012920" y="453060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187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4327920" y="453060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184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1387440" y="3727440"/>
            <a:ext cx="45705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 flipH="1">
            <a:off x="2436120" y="3619440"/>
            <a:ext cx="260280" cy="203400"/>
          </a:xfrm>
          <a:prstGeom prst="rightArrow">
            <a:avLst>
              <a:gd name="adj1" fmla="val 50000"/>
              <a:gd name="adj2" fmla="val 31991"/>
            </a:avLst>
          </a:prstGeom>
          <a:solidFill>
            <a:srgbClr val="ffc9e4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2806560" y="3619440"/>
            <a:ext cx="260640" cy="203400"/>
          </a:xfrm>
          <a:prstGeom prst="rightArrow">
            <a:avLst>
              <a:gd name="adj1" fmla="val 50000"/>
              <a:gd name="adj2" fmla="val 32035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4397400" y="361944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e3dcb7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3487680" y="361944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ffdc4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4094280" y="3619440"/>
            <a:ext cx="258480" cy="203400"/>
          </a:xfrm>
          <a:prstGeom prst="rightArrow">
            <a:avLst>
              <a:gd name="adj1" fmla="val 50000"/>
              <a:gd name="adj2" fmla="val 31770"/>
            </a:avLst>
          </a:prstGeom>
          <a:solidFill>
            <a:srgbClr val="f0c8b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5621400" y="362412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00d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 flipH="1">
            <a:off x="5295240" y="362412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 flipH="1">
            <a:off x="5576040" y="3641760"/>
            <a:ext cx="356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868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 flipH="1">
            <a:off x="5263920" y="3641760"/>
            <a:ext cx="356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868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3412800" y="3637080"/>
            <a:ext cx="356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867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2373840" y="3637080"/>
            <a:ext cx="356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866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2753280" y="3637080"/>
            <a:ext cx="356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866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4020840" y="3637080"/>
            <a:ext cx="356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867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4329720" y="3637080"/>
            <a:ext cx="356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867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1681200" y="3219480"/>
            <a:ext cx="45702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 flipH="1">
            <a:off x="1730520" y="3124080"/>
            <a:ext cx="258480" cy="203400"/>
          </a:xfrm>
          <a:prstGeom prst="rightArrow">
            <a:avLst>
              <a:gd name="adj1" fmla="val 50000"/>
              <a:gd name="adj2" fmla="val 31770"/>
            </a:avLst>
          </a:prstGeom>
          <a:solidFill>
            <a:srgbClr val="00d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2054160" y="312408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 flipH="1">
            <a:off x="2438280" y="3124080"/>
            <a:ext cx="260640" cy="203400"/>
          </a:xfrm>
          <a:prstGeom prst="rightArrow">
            <a:avLst>
              <a:gd name="adj1" fmla="val 50000"/>
              <a:gd name="adj2" fmla="val 32035"/>
            </a:avLst>
          </a:prstGeom>
          <a:solidFill>
            <a:srgbClr val="ffc9e4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2808360" y="3124080"/>
            <a:ext cx="260280" cy="203400"/>
          </a:xfrm>
          <a:prstGeom prst="rightArrow">
            <a:avLst>
              <a:gd name="adj1" fmla="val 50000"/>
              <a:gd name="adj2" fmla="val 31991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4398840" y="312408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e3dcb7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3489480" y="3124080"/>
            <a:ext cx="258480" cy="203400"/>
          </a:xfrm>
          <a:prstGeom prst="rightArrow">
            <a:avLst>
              <a:gd name="adj1" fmla="val 50000"/>
              <a:gd name="adj2" fmla="val 31770"/>
            </a:avLst>
          </a:prstGeom>
          <a:solidFill>
            <a:srgbClr val="ffdc4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1675440" y="31417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234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1987200" y="31417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2364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3412800" y="31417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243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2375640" y="31417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238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2736000" y="31417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240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4329720" y="31417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245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691200" y="4267080"/>
            <a:ext cx="587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Ergo0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 flipH="1">
            <a:off x="1731240" y="427824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00d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2055960" y="4278240"/>
            <a:ext cx="258480" cy="203400"/>
          </a:xfrm>
          <a:prstGeom prst="rightArrow">
            <a:avLst>
              <a:gd name="adj1" fmla="val 50000"/>
              <a:gd name="adj2" fmla="val 31770"/>
            </a:avLst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 flipH="1">
            <a:off x="2439360" y="4278240"/>
            <a:ext cx="260280" cy="203400"/>
          </a:xfrm>
          <a:prstGeom prst="rightArrow">
            <a:avLst>
              <a:gd name="adj1" fmla="val 50000"/>
              <a:gd name="adj2" fmla="val 31991"/>
            </a:avLst>
          </a:prstGeom>
          <a:solidFill>
            <a:srgbClr val="ffc9e4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2809800" y="4278240"/>
            <a:ext cx="260280" cy="203400"/>
          </a:xfrm>
          <a:prstGeom prst="rightArrow">
            <a:avLst>
              <a:gd name="adj1" fmla="val 50000"/>
              <a:gd name="adj2" fmla="val 31991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1676880" y="42958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7634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1989720" y="42958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765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2377800" y="42958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767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2737440" y="42958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770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4734000" y="4381560"/>
            <a:ext cx="6336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6261120" y="3218040"/>
            <a:ext cx="6336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 flipH="1">
            <a:off x="1631520" y="3970440"/>
            <a:ext cx="7308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64" name=""/>
          <p:cNvGrpSpPr/>
          <p:nvPr/>
        </p:nvGrpSpPr>
        <p:grpSpPr>
          <a:xfrm>
            <a:off x="4784760" y="3898800"/>
            <a:ext cx="96480" cy="131760"/>
            <a:chOff x="4784760" y="3898800"/>
            <a:chExt cx="96480" cy="131760"/>
          </a:xfrm>
        </p:grpSpPr>
        <p:sp>
          <p:nvSpPr>
            <p:cNvPr id="265" name=""/>
            <p:cNvSpPr/>
            <p:nvPr/>
          </p:nvSpPr>
          <p:spPr>
            <a:xfrm>
              <a:off x="4784760" y="3898800"/>
              <a:ext cx="88920" cy="1317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81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 rot="5400000">
              <a:off x="4782600" y="3925800"/>
              <a:ext cx="115920" cy="8100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9440" bIns="-19440" anchor="ctr">
              <a:noAutofit/>
            </a:bodyPr>
            <a:p>
              <a:pPr>
                <a:lnSpc>
                  <a:spcPct val="81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67" name=""/>
          <p:cNvSpPr/>
          <p:nvPr/>
        </p:nvSpPr>
        <p:spPr>
          <a:xfrm>
            <a:off x="4994280" y="3914640"/>
            <a:ext cx="254160" cy="108000"/>
          </a:xfrm>
          <a:custGeom>
            <a:avLst/>
            <a:gdLst>
              <a:gd name="textAreaLeft" fmla="*/ 0 w 254160"/>
              <a:gd name="textAreaRight" fmla="*/ 254520 w 254160"/>
              <a:gd name="textAreaTop" fmla="*/ 0 h 108000"/>
              <a:gd name="textAreaBottom" fmla="*/ 108360 h 108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771b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4916520" y="3882960"/>
            <a:ext cx="380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542r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4994280" y="3165480"/>
            <a:ext cx="254160" cy="108000"/>
          </a:xfrm>
          <a:custGeom>
            <a:avLst/>
            <a:gdLst>
              <a:gd name="textAreaLeft" fmla="*/ 0 w 254160"/>
              <a:gd name="textAreaRight" fmla="*/ 254520 w 254160"/>
              <a:gd name="textAreaTop" fmla="*/ 0 h 108000"/>
              <a:gd name="textAreaBottom" fmla="*/ 108360 h 108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771b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4915080" y="3139920"/>
            <a:ext cx="380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2474r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71" name=""/>
          <p:cNvGrpSpPr/>
          <p:nvPr/>
        </p:nvGrpSpPr>
        <p:grpSpPr>
          <a:xfrm>
            <a:off x="4691160" y="3394080"/>
            <a:ext cx="96480" cy="131760"/>
            <a:chOff x="4691160" y="3394080"/>
            <a:chExt cx="96480" cy="131760"/>
          </a:xfrm>
        </p:grpSpPr>
        <p:sp>
          <p:nvSpPr>
            <p:cNvPr id="272" name=""/>
            <p:cNvSpPr/>
            <p:nvPr/>
          </p:nvSpPr>
          <p:spPr>
            <a:xfrm>
              <a:off x="4691160" y="3394080"/>
              <a:ext cx="88920" cy="1317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81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 rot="5400000">
              <a:off x="4689000" y="3420720"/>
              <a:ext cx="115920" cy="8100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9440" bIns="-19440" anchor="ctr">
              <a:noAutofit/>
            </a:bodyPr>
            <a:p>
              <a:pPr>
                <a:lnSpc>
                  <a:spcPct val="81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4" name=""/>
          <p:cNvGrpSpPr/>
          <p:nvPr/>
        </p:nvGrpSpPr>
        <p:grpSpPr>
          <a:xfrm>
            <a:off x="4773600" y="3395520"/>
            <a:ext cx="96480" cy="131760"/>
            <a:chOff x="4773600" y="3395520"/>
            <a:chExt cx="96480" cy="131760"/>
          </a:xfrm>
        </p:grpSpPr>
        <p:sp>
          <p:nvSpPr>
            <p:cNvPr id="275" name=""/>
            <p:cNvSpPr/>
            <p:nvPr/>
          </p:nvSpPr>
          <p:spPr>
            <a:xfrm>
              <a:off x="4773600" y="3395520"/>
              <a:ext cx="88920" cy="1317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81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 rot="5400000">
              <a:off x="4771440" y="3422520"/>
              <a:ext cx="115920" cy="8100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9440" bIns="-19440" anchor="ctr">
              <a:noAutofit/>
            </a:bodyPr>
            <a:p>
              <a:pPr>
                <a:lnSpc>
                  <a:spcPct val="81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7" name=""/>
          <p:cNvGrpSpPr/>
          <p:nvPr/>
        </p:nvGrpSpPr>
        <p:grpSpPr>
          <a:xfrm>
            <a:off x="4842000" y="3397320"/>
            <a:ext cx="96480" cy="131760"/>
            <a:chOff x="4842000" y="3397320"/>
            <a:chExt cx="96480" cy="131760"/>
          </a:xfrm>
        </p:grpSpPr>
        <p:sp>
          <p:nvSpPr>
            <p:cNvPr id="278" name=""/>
            <p:cNvSpPr/>
            <p:nvPr/>
          </p:nvSpPr>
          <p:spPr>
            <a:xfrm>
              <a:off x="4842000" y="3397320"/>
              <a:ext cx="88920" cy="1317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81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 rot="5400000">
              <a:off x="4839840" y="3423960"/>
              <a:ext cx="115920" cy="8100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9440" bIns="-19440" anchor="ctr">
              <a:noAutofit/>
            </a:bodyPr>
            <a:p>
              <a:pPr>
                <a:lnSpc>
                  <a:spcPct val="81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80" name=""/>
          <p:cNvSpPr/>
          <p:nvPr/>
        </p:nvSpPr>
        <p:spPr>
          <a:xfrm>
            <a:off x="4994280" y="3406680"/>
            <a:ext cx="254160" cy="108000"/>
          </a:xfrm>
          <a:custGeom>
            <a:avLst/>
            <a:gdLst>
              <a:gd name="textAreaLeft" fmla="*/ 0 w 254160"/>
              <a:gd name="textAreaRight" fmla="*/ 254520 w 254160"/>
              <a:gd name="textAreaTop" fmla="*/ 0 h 108000"/>
              <a:gd name="textAreaBottom" fmla="*/ 108360 h 108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771b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4918320" y="3381480"/>
            <a:ext cx="380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4840r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3797280" y="4324320"/>
            <a:ext cx="254160" cy="108000"/>
          </a:xfrm>
          <a:custGeom>
            <a:avLst/>
            <a:gdLst>
              <a:gd name="textAreaLeft" fmla="*/ 0 w 254160"/>
              <a:gd name="textAreaRight" fmla="*/ 254520 w 254160"/>
              <a:gd name="textAreaTop" fmla="*/ 0 h 108000"/>
              <a:gd name="textAreaBottom" fmla="*/ 108360 h 108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3717360" y="4299120"/>
            <a:ext cx="380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7744r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 flipH="1">
            <a:off x="1599840" y="4622760"/>
            <a:ext cx="73080" cy="18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5950080" y="3724200"/>
            <a:ext cx="63360" cy="18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4994280" y="3683160"/>
            <a:ext cx="254160" cy="107640"/>
          </a:xfrm>
          <a:custGeom>
            <a:avLst/>
            <a:gdLst>
              <a:gd name="textAreaLeft" fmla="*/ 0 w 254160"/>
              <a:gd name="textAreaRight" fmla="*/ 254520 w 254160"/>
              <a:gd name="textAreaTop" fmla="*/ 0 h 107640"/>
              <a:gd name="textAreaBottom" fmla="*/ 108000 h 107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771b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691560" y="5403960"/>
            <a:ext cx="56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Sakl0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692280" y="5894280"/>
            <a:ext cx="549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Klth0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 flipH="1">
            <a:off x="1482840" y="5905440"/>
            <a:ext cx="258480" cy="203400"/>
          </a:xfrm>
          <a:prstGeom prst="rightArrow">
            <a:avLst>
              <a:gd name="adj1" fmla="val 50000"/>
              <a:gd name="adj2" fmla="val 31770"/>
            </a:avLst>
          </a:prstGeom>
          <a:solidFill>
            <a:srgbClr val="ff9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 flipH="1">
            <a:off x="2129760" y="590544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5261040" y="590544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4be35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 flipH="1">
            <a:off x="4253760" y="590544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 flipH="1">
            <a:off x="4609440" y="590544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1427760" y="59230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394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2064240" y="59230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392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4179600" y="59230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386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4536000" y="59230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383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5182920" y="59230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3794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691920" y="5159520"/>
            <a:ext cx="575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Zyro0B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 flipH="1">
            <a:off x="1483560" y="541512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9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 flipH="1">
            <a:off x="2129760" y="541512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2468520" y="541512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 flipH="1">
            <a:off x="3575880" y="541512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>
            <a:off x="5261040" y="541512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4be35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 flipH="1">
            <a:off x="4257000" y="541512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 flipH="1">
            <a:off x="4609440" y="541512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3881520" y="5415120"/>
            <a:ext cx="314280" cy="203040"/>
          </a:xfrm>
          <a:prstGeom prst="rightArrow">
            <a:avLst>
              <a:gd name="adj1" fmla="val 50000"/>
              <a:gd name="adj2" fmla="val 38697"/>
            </a:avLst>
          </a:prstGeom>
          <a:solidFill>
            <a:srgbClr val="ffffff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1425960" y="543240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454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2075400" y="543240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47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2386440" y="543240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49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3528720" y="543240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65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4190760" y="543240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69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3807720" y="5419800"/>
            <a:ext cx="4413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600" spc="-1" strike="noStrike">
                <a:solidFill>
                  <a:srgbClr val="ff0000"/>
                </a:solidFill>
                <a:latin typeface="Arial"/>
                <a:ea typeface="Arial"/>
              </a:rPr>
              <a:t>03674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4543200" y="543240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71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4871160" y="543240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729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5586480" y="5524560"/>
            <a:ext cx="6336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690480" y="5648400"/>
            <a:ext cx="671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Klwa.s2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>
            <a:off x="5261040" y="614988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4be35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 flipH="1">
            <a:off x="4253760" y="614988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 flipH="1">
            <a:off x="4609440" y="614988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>
            <a:off x="4190760" y="61675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9734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>
            <a:off x="4536000" y="61675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971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>
            <a:off x="5182200" y="61675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966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690840" y="6381720"/>
            <a:ext cx="531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Klla0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 flipH="1">
            <a:off x="1482840" y="6391440"/>
            <a:ext cx="258480" cy="203040"/>
          </a:xfrm>
          <a:prstGeom prst="rightArrow">
            <a:avLst>
              <a:gd name="adj1" fmla="val 50000"/>
              <a:gd name="adj2" fmla="val 31826"/>
            </a:avLst>
          </a:prstGeom>
          <a:solidFill>
            <a:srgbClr val="ff9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 flipH="1">
            <a:off x="2129760" y="639144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>
            <a:off x="5261040" y="639144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4be35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 flipH="1">
            <a:off x="4253760" y="639144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 flipH="1">
            <a:off x="4609440" y="639144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>
            <a:off x="1427760" y="64087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5435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2063520" y="64087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5479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4190040" y="64087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1145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4536000" y="64087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1167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5182920" y="64087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1211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 flipH="1">
            <a:off x="1482840" y="5659560"/>
            <a:ext cx="258480" cy="203040"/>
          </a:xfrm>
          <a:prstGeom prst="rightArrow">
            <a:avLst>
              <a:gd name="adj1" fmla="val 50000"/>
              <a:gd name="adj2" fmla="val 31826"/>
            </a:avLst>
          </a:prstGeom>
          <a:solidFill>
            <a:srgbClr val="ff9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 flipH="1">
            <a:off x="2129760" y="565956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5261040" y="565956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4be35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 flipH="1">
            <a:off x="4253760" y="565956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 flipH="1">
            <a:off x="4609440" y="565956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1451520" y="5676840"/>
            <a:ext cx="3207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935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2097720" y="5676840"/>
            <a:ext cx="3207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935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4220280" y="5676840"/>
            <a:ext cx="3207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934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4574160" y="5676840"/>
            <a:ext cx="3207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934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5196600" y="5676840"/>
            <a:ext cx="3207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932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 flipH="1">
            <a:off x="1483560" y="518328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9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 flipH="1">
            <a:off x="3575880" y="518328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5262480" y="518328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4be35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 flipH="1">
            <a:off x="4257000" y="518328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>
            <a:off x="1429200" y="52005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715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>
            <a:off x="4196160" y="52005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723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"/>
          <p:cNvSpPr/>
          <p:nvPr/>
        </p:nvSpPr>
        <p:spPr>
          <a:xfrm>
            <a:off x="3524040" y="52005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721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"/>
          <p:cNvSpPr/>
          <p:nvPr/>
        </p:nvSpPr>
        <p:spPr>
          <a:xfrm>
            <a:off x="5183640" y="51991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7304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"/>
          <p:cNvSpPr/>
          <p:nvPr/>
        </p:nvSpPr>
        <p:spPr>
          <a:xfrm>
            <a:off x="691920" y="6137280"/>
            <a:ext cx="575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Ergo0F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"/>
          <p:cNvSpPr/>
          <p:nvPr/>
        </p:nvSpPr>
        <p:spPr>
          <a:xfrm flipH="1">
            <a:off x="1486080" y="6148440"/>
            <a:ext cx="258480" cy="203040"/>
          </a:xfrm>
          <a:prstGeom prst="rightArrow">
            <a:avLst>
              <a:gd name="adj1" fmla="val 50000"/>
              <a:gd name="adj2" fmla="val 31826"/>
            </a:avLst>
          </a:prstGeom>
          <a:solidFill>
            <a:srgbClr val="ff9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"/>
          <p:cNvSpPr/>
          <p:nvPr/>
        </p:nvSpPr>
        <p:spPr>
          <a:xfrm>
            <a:off x="2468520" y="614376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"/>
          <p:cNvSpPr/>
          <p:nvPr/>
        </p:nvSpPr>
        <p:spPr>
          <a:xfrm flipH="1">
            <a:off x="3577680" y="614376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"/>
          <p:cNvSpPr/>
          <p:nvPr/>
        </p:nvSpPr>
        <p:spPr>
          <a:xfrm>
            <a:off x="1425960" y="616104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982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"/>
          <p:cNvSpPr/>
          <p:nvPr/>
        </p:nvSpPr>
        <p:spPr>
          <a:xfrm>
            <a:off x="2391480" y="616104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980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"/>
          <p:cNvSpPr/>
          <p:nvPr/>
        </p:nvSpPr>
        <p:spPr>
          <a:xfrm>
            <a:off x="3525480" y="616104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975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"/>
          <p:cNvSpPr/>
          <p:nvPr/>
        </p:nvSpPr>
        <p:spPr>
          <a:xfrm>
            <a:off x="5586480" y="6014880"/>
            <a:ext cx="63360" cy="18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"/>
          <p:cNvSpPr/>
          <p:nvPr/>
        </p:nvSpPr>
        <p:spPr>
          <a:xfrm>
            <a:off x="5586480" y="6492960"/>
            <a:ext cx="6336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"/>
          <p:cNvSpPr/>
          <p:nvPr/>
        </p:nvSpPr>
        <p:spPr>
          <a:xfrm>
            <a:off x="5586480" y="5276880"/>
            <a:ext cx="6336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"/>
          <p:cNvSpPr/>
          <p:nvPr/>
        </p:nvSpPr>
        <p:spPr>
          <a:xfrm flipH="1">
            <a:off x="1355400" y="5767560"/>
            <a:ext cx="7308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64" name=""/>
          <p:cNvGrpSpPr/>
          <p:nvPr/>
        </p:nvGrpSpPr>
        <p:grpSpPr>
          <a:xfrm>
            <a:off x="2782800" y="5456160"/>
            <a:ext cx="96480" cy="131760"/>
            <a:chOff x="2782800" y="5456160"/>
            <a:chExt cx="96480" cy="131760"/>
          </a:xfrm>
        </p:grpSpPr>
        <p:sp>
          <p:nvSpPr>
            <p:cNvPr id="365" name=""/>
            <p:cNvSpPr/>
            <p:nvPr/>
          </p:nvSpPr>
          <p:spPr>
            <a:xfrm>
              <a:off x="2782800" y="5456160"/>
              <a:ext cx="88920" cy="1317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81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 rot="5400000">
              <a:off x="2780640" y="5483160"/>
              <a:ext cx="115920" cy="8100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9440" bIns="-19440" anchor="ctr">
              <a:noAutofit/>
            </a:bodyPr>
            <a:p>
              <a:pPr>
                <a:lnSpc>
                  <a:spcPct val="81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67" name=""/>
          <p:cNvGrpSpPr/>
          <p:nvPr/>
        </p:nvGrpSpPr>
        <p:grpSpPr>
          <a:xfrm>
            <a:off x="2890800" y="5457960"/>
            <a:ext cx="96480" cy="131760"/>
            <a:chOff x="2890800" y="5457960"/>
            <a:chExt cx="96480" cy="131760"/>
          </a:xfrm>
        </p:grpSpPr>
        <p:sp>
          <p:nvSpPr>
            <p:cNvPr id="368" name=""/>
            <p:cNvSpPr/>
            <p:nvPr/>
          </p:nvSpPr>
          <p:spPr>
            <a:xfrm>
              <a:off x="2890800" y="5457960"/>
              <a:ext cx="88920" cy="1317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81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 rot="5400000">
              <a:off x="2888640" y="5484600"/>
              <a:ext cx="115920" cy="8100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9440" bIns="-19440" anchor="ctr">
              <a:noAutofit/>
            </a:bodyPr>
            <a:p>
              <a:pPr>
                <a:lnSpc>
                  <a:spcPct val="81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70" name=""/>
          <p:cNvGrpSpPr/>
          <p:nvPr/>
        </p:nvGrpSpPr>
        <p:grpSpPr>
          <a:xfrm>
            <a:off x="3003480" y="5459400"/>
            <a:ext cx="96480" cy="131760"/>
            <a:chOff x="3003480" y="5459400"/>
            <a:chExt cx="96480" cy="131760"/>
          </a:xfrm>
        </p:grpSpPr>
        <p:sp>
          <p:nvSpPr>
            <p:cNvPr id="371" name=""/>
            <p:cNvSpPr/>
            <p:nvPr/>
          </p:nvSpPr>
          <p:spPr>
            <a:xfrm>
              <a:off x="3003480" y="5459400"/>
              <a:ext cx="88920" cy="1317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81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 rot="5400000">
              <a:off x="3001320" y="5486040"/>
              <a:ext cx="115920" cy="8100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9440" bIns="-19440" anchor="ctr">
              <a:noAutofit/>
            </a:bodyPr>
            <a:p>
              <a:pPr>
                <a:lnSpc>
                  <a:spcPct val="81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73" name=""/>
          <p:cNvSpPr/>
          <p:nvPr/>
        </p:nvSpPr>
        <p:spPr>
          <a:xfrm>
            <a:off x="3281400" y="5468760"/>
            <a:ext cx="253800" cy="108000"/>
          </a:xfrm>
          <a:custGeom>
            <a:avLst/>
            <a:gdLst>
              <a:gd name="textAreaLeft" fmla="*/ 0 w 253800"/>
              <a:gd name="textAreaRight" fmla="*/ 254160 w 253800"/>
              <a:gd name="textAreaTop" fmla="*/ 0 h 108000"/>
              <a:gd name="textAreaBottom" fmla="*/ 108360 h 108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87a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74" name=""/>
          <p:cNvGrpSpPr/>
          <p:nvPr/>
        </p:nvGrpSpPr>
        <p:grpSpPr>
          <a:xfrm>
            <a:off x="3086280" y="5459400"/>
            <a:ext cx="96480" cy="131760"/>
            <a:chOff x="3086280" y="5459400"/>
            <a:chExt cx="96480" cy="131760"/>
          </a:xfrm>
        </p:grpSpPr>
        <p:sp>
          <p:nvSpPr>
            <p:cNvPr id="375" name=""/>
            <p:cNvSpPr/>
            <p:nvPr/>
          </p:nvSpPr>
          <p:spPr>
            <a:xfrm>
              <a:off x="3086280" y="5459400"/>
              <a:ext cx="88560" cy="1317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81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"/>
            <p:cNvSpPr/>
            <p:nvPr/>
          </p:nvSpPr>
          <p:spPr>
            <a:xfrm rot="5400000">
              <a:off x="3084480" y="5486400"/>
              <a:ext cx="115920" cy="8064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9800" bIns="-19800" anchor="ctr">
              <a:noAutofit/>
            </a:bodyPr>
            <a:p>
              <a:pPr>
                <a:lnSpc>
                  <a:spcPct val="81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77" name=""/>
          <p:cNvGrpSpPr/>
          <p:nvPr/>
        </p:nvGrpSpPr>
        <p:grpSpPr>
          <a:xfrm>
            <a:off x="3146400" y="5460840"/>
            <a:ext cx="96480" cy="131760"/>
            <a:chOff x="3146400" y="5460840"/>
            <a:chExt cx="96480" cy="131760"/>
          </a:xfrm>
        </p:grpSpPr>
        <p:sp>
          <p:nvSpPr>
            <p:cNvPr id="378" name=""/>
            <p:cNvSpPr/>
            <p:nvPr/>
          </p:nvSpPr>
          <p:spPr>
            <a:xfrm>
              <a:off x="3146400" y="5460840"/>
              <a:ext cx="88920" cy="1317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81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"/>
            <p:cNvSpPr/>
            <p:nvPr/>
          </p:nvSpPr>
          <p:spPr>
            <a:xfrm rot="5400000">
              <a:off x="3144240" y="5487840"/>
              <a:ext cx="115920" cy="8100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9440" bIns="-19440" anchor="ctr">
              <a:noAutofit/>
            </a:bodyPr>
            <a:p>
              <a:pPr>
                <a:lnSpc>
                  <a:spcPct val="81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80" name=""/>
          <p:cNvSpPr/>
          <p:nvPr/>
        </p:nvSpPr>
        <p:spPr>
          <a:xfrm>
            <a:off x="3207600" y="5438880"/>
            <a:ext cx="380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630r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"/>
          <p:cNvSpPr/>
          <p:nvPr/>
        </p:nvSpPr>
        <p:spPr>
          <a:xfrm flipH="1">
            <a:off x="4601520" y="518328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"/>
          <p:cNvSpPr/>
          <p:nvPr/>
        </p:nvSpPr>
        <p:spPr>
          <a:xfrm>
            <a:off x="4536720" y="52005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726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"/>
          <p:cNvSpPr/>
          <p:nvPr/>
        </p:nvSpPr>
        <p:spPr>
          <a:xfrm>
            <a:off x="5186880" y="543240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74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"/>
          <p:cNvSpPr/>
          <p:nvPr/>
        </p:nvSpPr>
        <p:spPr>
          <a:xfrm>
            <a:off x="2328840" y="517860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"/>
          <p:cNvSpPr/>
          <p:nvPr/>
        </p:nvSpPr>
        <p:spPr>
          <a:xfrm>
            <a:off x="2250720" y="519264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717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"/>
          <p:cNvSpPr/>
          <p:nvPr/>
        </p:nvSpPr>
        <p:spPr>
          <a:xfrm>
            <a:off x="3281400" y="5230800"/>
            <a:ext cx="253800" cy="108000"/>
          </a:xfrm>
          <a:custGeom>
            <a:avLst/>
            <a:gdLst>
              <a:gd name="textAreaLeft" fmla="*/ 0 w 253800"/>
              <a:gd name="textAreaRight" fmla="*/ 254160 w 253800"/>
              <a:gd name="textAreaTop" fmla="*/ 0 h 108000"/>
              <a:gd name="textAreaBottom" fmla="*/ 108360 h 108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87a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"/>
          <p:cNvSpPr/>
          <p:nvPr/>
        </p:nvSpPr>
        <p:spPr>
          <a:xfrm>
            <a:off x="3206880" y="5205240"/>
            <a:ext cx="380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7194r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"/>
          <p:cNvSpPr/>
          <p:nvPr/>
        </p:nvSpPr>
        <p:spPr>
          <a:xfrm flipH="1">
            <a:off x="4931640" y="518004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cccc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"/>
          <p:cNvSpPr/>
          <p:nvPr/>
        </p:nvSpPr>
        <p:spPr>
          <a:xfrm>
            <a:off x="4871880" y="52005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728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"/>
          <p:cNvSpPr/>
          <p:nvPr/>
        </p:nvSpPr>
        <p:spPr>
          <a:xfrm flipH="1">
            <a:off x="4931640" y="590868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cccc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"/>
          <p:cNvSpPr/>
          <p:nvPr/>
        </p:nvSpPr>
        <p:spPr>
          <a:xfrm>
            <a:off x="4868640" y="592920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381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"/>
          <p:cNvSpPr/>
          <p:nvPr/>
        </p:nvSpPr>
        <p:spPr>
          <a:xfrm flipH="1">
            <a:off x="4931640" y="615168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cccc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"/>
          <p:cNvSpPr/>
          <p:nvPr/>
        </p:nvSpPr>
        <p:spPr>
          <a:xfrm>
            <a:off x="4874040" y="617220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969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"/>
          <p:cNvSpPr/>
          <p:nvPr/>
        </p:nvSpPr>
        <p:spPr>
          <a:xfrm flipH="1">
            <a:off x="4931640" y="639612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cccc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"/>
          <p:cNvSpPr/>
          <p:nvPr/>
        </p:nvSpPr>
        <p:spPr>
          <a:xfrm>
            <a:off x="4869360" y="641664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1189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"/>
          <p:cNvSpPr/>
          <p:nvPr/>
        </p:nvSpPr>
        <p:spPr>
          <a:xfrm flipH="1">
            <a:off x="4928400" y="566424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cccc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"/>
          <p:cNvSpPr/>
          <p:nvPr/>
        </p:nvSpPr>
        <p:spPr>
          <a:xfrm>
            <a:off x="3281400" y="5958000"/>
            <a:ext cx="253800" cy="108000"/>
          </a:xfrm>
          <a:custGeom>
            <a:avLst/>
            <a:gdLst>
              <a:gd name="textAreaLeft" fmla="*/ 0 w 253800"/>
              <a:gd name="textAreaRight" fmla="*/ 254160 w 253800"/>
              <a:gd name="textAreaTop" fmla="*/ 0 h 108000"/>
              <a:gd name="textAreaBottom" fmla="*/ 108360 h 108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87a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"/>
          <p:cNvSpPr/>
          <p:nvPr/>
        </p:nvSpPr>
        <p:spPr>
          <a:xfrm>
            <a:off x="3213360" y="5932440"/>
            <a:ext cx="380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3882r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99" name=""/>
          <p:cNvGrpSpPr/>
          <p:nvPr/>
        </p:nvGrpSpPr>
        <p:grpSpPr>
          <a:xfrm>
            <a:off x="3125880" y="5943600"/>
            <a:ext cx="96480" cy="131760"/>
            <a:chOff x="3125880" y="5943600"/>
            <a:chExt cx="96480" cy="131760"/>
          </a:xfrm>
        </p:grpSpPr>
        <p:sp>
          <p:nvSpPr>
            <p:cNvPr id="400" name=""/>
            <p:cNvSpPr/>
            <p:nvPr/>
          </p:nvSpPr>
          <p:spPr>
            <a:xfrm>
              <a:off x="3125880" y="5943600"/>
              <a:ext cx="88920" cy="1317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81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"/>
            <p:cNvSpPr/>
            <p:nvPr/>
          </p:nvSpPr>
          <p:spPr>
            <a:xfrm rot="5400000">
              <a:off x="3123720" y="5970240"/>
              <a:ext cx="115920" cy="8100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9440" bIns="-19440" anchor="ctr">
              <a:noAutofit/>
            </a:bodyPr>
            <a:p>
              <a:pPr>
                <a:lnSpc>
                  <a:spcPct val="81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02" name=""/>
          <p:cNvSpPr/>
          <p:nvPr/>
        </p:nvSpPr>
        <p:spPr>
          <a:xfrm flipH="1">
            <a:off x="1358640" y="6013440"/>
            <a:ext cx="7308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"/>
          <p:cNvSpPr/>
          <p:nvPr/>
        </p:nvSpPr>
        <p:spPr>
          <a:xfrm flipH="1">
            <a:off x="1364760" y="6249960"/>
            <a:ext cx="7308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"/>
          <p:cNvSpPr/>
          <p:nvPr/>
        </p:nvSpPr>
        <p:spPr>
          <a:xfrm>
            <a:off x="3281400" y="6197760"/>
            <a:ext cx="253800" cy="107640"/>
          </a:xfrm>
          <a:custGeom>
            <a:avLst/>
            <a:gdLst>
              <a:gd name="textAreaLeft" fmla="*/ 0 w 253800"/>
              <a:gd name="textAreaRight" fmla="*/ 254160 w 253800"/>
              <a:gd name="textAreaTop" fmla="*/ 0 h 107640"/>
              <a:gd name="textAreaBottom" fmla="*/ 108000 h 107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87a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"/>
          <p:cNvSpPr/>
          <p:nvPr/>
        </p:nvSpPr>
        <p:spPr>
          <a:xfrm>
            <a:off x="3206880" y="6167520"/>
            <a:ext cx="380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9778r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"/>
          <p:cNvSpPr/>
          <p:nvPr/>
        </p:nvSpPr>
        <p:spPr>
          <a:xfrm flipH="1">
            <a:off x="1801080" y="639288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"/>
          <p:cNvSpPr/>
          <p:nvPr/>
        </p:nvSpPr>
        <p:spPr>
          <a:xfrm>
            <a:off x="1735560" y="64101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5457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"/>
          <p:cNvSpPr/>
          <p:nvPr/>
        </p:nvSpPr>
        <p:spPr>
          <a:xfrm>
            <a:off x="2708640" y="6381720"/>
            <a:ext cx="531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Klla0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"/>
          <p:cNvSpPr/>
          <p:nvPr/>
        </p:nvSpPr>
        <p:spPr>
          <a:xfrm>
            <a:off x="3281400" y="6442200"/>
            <a:ext cx="253800" cy="108000"/>
          </a:xfrm>
          <a:custGeom>
            <a:avLst/>
            <a:gdLst>
              <a:gd name="textAreaLeft" fmla="*/ 0 w 253800"/>
              <a:gd name="textAreaRight" fmla="*/ 254160 w 253800"/>
              <a:gd name="textAreaTop" fmla="*/ 0 h 108000"/>
              <a:gd name="textAreaBottom" fmla="*/ 108360 h 108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87a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"/>
          <p:cNvSpPr/>
          <p:nvPr/>
        </p:nvSpPr>
        <p:spPr>
          <a:xfrm>
            <a:off x="3205080" y="6411960"/>
            <a:ext cx="380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1123r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"/>
          <p:cNvSpPr/>
          <p:nvPr/>
        </p:nvSpPr>
        <p:spPr>
          <a:xfrm>
            <a:off x="4910760" y="5683320"/>
            <a:ext cx="3207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933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"/>
          <p:cNvSpPr/>
          <p:nvPr/>
        </p:nvSpPr>
        <p:spPr>
          <a:xfrm>
            <a:off x="3281400" y="5711760"/>
            <a:ext cx="253800" cy="108000"/>
          </a:xfrm>
          <a:custGeom>
            <a:avLst/>
            <a:gdLst>
              <a:gd name="textAreaLeft" fmla="*/ 0 w 253800"/>
              <a:gd name="textAreaRight" fmla="*/ 254160 w 253800"/>
              <a:gd name="textAreaTop" fmla="*/ 0 h 108000"/>
              <a:gd name="textAreaBottom" fmla="*/ 108360 h 108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87a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"/>
          <p:cNvSpPr/>
          <p:nvPr/>
        </p:nvSpPr>
        <p:spPr>
          <a:xfrm>
            <a:off x="691560" y="7284960"/>
            <a:ext cx="56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Sakl0B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"/>
          <p:cNvSpPr/>
          <p:nvPr/>
        </p:nvSpPr>
        <p:spPr>
          <a:xfrm>
            <a:off x="692280" y="7775640"/>
            <a:ext cx="549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Klth0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"/>
          <p:cNvSpPr/>
          <p:nvPr/>
        </p:nvSpPr>
        <p:spPr>
          <a:xfrm>
            <a:off x="1446120" y="7894800"/>
            <a:ext cx="28796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"/>
          <p:cNvSpPr/>
          <p:nvPr/>
        </p:nvSpPr>
        <p:spPr>
          <a:xfrm>
            <a:off x="2230560" y="7786800"/>
            <a:ext cx="258480" cy="203040"/>
          </a:xfrm>
          <a:prstGeom prst="rightArrow">
            <a:avLst>
              <a:gd name="adj1" fmla="val 50000"/>
              <a:gd name="adj2" fmla="val 31826"/>
            </a:avLst>
          </a:prstGeom>
          <a:solidFill>
            <a:srgbClr val="ff9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"/>
          <p:cNvSpPr/>
          <p:nvPr/>
        </p:nvSpPr>
        <p:spPr>
          <a:xfrm flipH="1">
            <a:off x="2938320" y="7786800"/>
            <a:ext cx="260640" cy="203040"/>
          </a:xfrm>
          <a:prstGeom prst="rightArrow">
            <a:avLst>
              <a:gd name="adj1" fmla="val 50000"/>
              <a:gd name="adj2" fmla="val 32092"/>
            </a:avLst>
          </a:prstGeom>
          <a:solidFill>
            <a:srgbClr val="ff66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"/>
          <p:cNvSpPr/>
          <p:nvPr/>
        </p:nvSpPr>
        <p:spPr>
          <a:xfrm flipH="1">
            <a:off x="3307680" y="778680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"/>
          <p:cNvSpPr/>
          <p:nvPr/>
        </p:nvSpPr>
        <p:spPr>
          <a:xfrm>
            <a:off x="3989520" y="7786800"/>
            <a:ext cx="258480" cy="203040"/>
          </a:xfrm>
          <a:prstGeom prst="rightArrow">
            <a:avLst>
              <a:gd name="adj1" fmla="val 50000"/>
              <a:gd name="adj2" fmla="val 31826"/>
            </a:avLst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"/>
          <p:cNvSpPr/>
          <p:nvPr/>
        </p:nvSpPr>
        <p:spPr>
          <a:xfrm>
            <a:off x="2162520" y="78040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14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"/>
          <p:cNvSpPr/>
          <p:nvPr/>
        </p:nvSpPr>
        <p:spPr>
          <a:xfrm>
            <a:off x="3912840" y="78040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05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"/>
          <p:cNvSpPr/>
          <p:nvPr/>
        </p:nvSpPr>
        <p:spPr>
          <a:xfrm>
            <a:off x="2874600" y="78040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10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"/>
          <p:cNvSpPr/>
          <p:nvPr/>
        </p:nvSpPr>
        <p:spPr>
          <a:xfrm>
            <a:off x="3254040" y="78040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08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"/>
          <p:cNvSpPr/>
          <p:nvPr/>
        </p:nvSpPr>
        <p:spPr>
          <a:xfrm>
            <a:off x="691560" y="7040520"/>
            <a:ext cx="56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Zyro0F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"/>
          <p:cNvSpPr/>
          <p:nvPr/>
        </p:nvSpPr>
        <p:spPr>
          <a:xfrm>
            <a:off x="1446120" y="7404120"/>
            <a:ext cx="28796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"/>
          <p:cNvSpPr/>
          <p:nvPr/>
        </p:nvSpPr>
        <p:spPr>
          <a:xfrm>
            <a:off x="2230560" y="7296120"/>
            <a:ext cx="258480" cy="203400"/>
          </a:xfrm>
          <a:prstGeom prst="rightArrow">
            <a:avLst>
              <a:gd name="adj1" fmla="val 50000"/>
              <a:gd name="adj2" fmla="val 31770"/>
            </a:avLst>
          </a:prstGeom>
          <a:solidFill>
            <a:srgbClr val="ff9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"/>
          <p:cNvSpPr/>
          <p:nvPr/>
        </p:nvSpPr>
        <p:spPr>
          <a:xfrm>
            <a:off x="2554200" y="7296120"/>
            <a:ext cx="260280" cy="203400"/>
          </a:xfrm>
          <a:prstGeom prst="rightArrow">
            <a:avLst>
              <a:gd name="adj1" fmla="val 50000"/>
              <a:gd name="adj2" fmla="val 31991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"/>
          <p:cNvSpPr/>
          <p:nvPr/>
        </p:nvSpPr>
        <p:spPr>
          <a:xfrm flipH="1">
            <a:off x="2939400" y="729612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ff66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"/>
          <p:cNvSpPr/>
          <p:nvPr/>
        </p:nvSpPr>
        <p:spPr>
          <a:xfrm flipH="1">
            <a:off x="3307680" y="7296120"/>
            <a:ext cx="260280" cy="203400"/>
          </a:xfrm>
          <a:prstGeom prst="rightArrow">
            <a:avLst>
              <a:gd name="adj1" fmla="val 50000"/>
              <a:gd name="adj2" fmla="val 31991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"/>
          <p:cNvSpPr/>
          <p:nvPr/>
        </p:nvSpPr>
        <p:spPr>
          <a:xfrm>
            <a:off x="3990960" y="729612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"/>
          <p:cNvSpPr/>
          <p:nvPr/>
        </p:nvSpPr>
        <p:spPr>
          <a:xfrm flipH="1">
            <a:off x="3614760" y="7289640"/>
            <a:ext cx="339840" cy="209880"/>
          </a:xfrm>
          <a:prstGeom prst="rightArrow">
            <a:avLst>
              <a:gd name="adj1" fmla="val 50000"/>
              <a:gd name="adj2" fmla="val 40480"/>
            </a:avLst>
          </a:prstGeom>
          <a:solidFill>
            <a:srgbClr val="ffffff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"/>
          <p:cNvSpPr/>
          <p:nvPr/>
        </p:nvSpPr>
        <p:spPr>
          <a:xfrm>
            <a:off x="2153880" y="73137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1694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"/>
          <p:cNvSpPr/>
          <p:nvPr/>
        </p:nvSpPr>
        <p:spPr>
          <a:xfrm>
            <a:off x="2480040" y="73137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171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"/>
          <p:cNvSpPr/>
          <p:nvPr/>
        </p:nvSpPr>
        <p:spPr>
          <a:xfrm>
            <a:off x="2881080" y="73137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173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"/>
          <p:cNvSpPr/>
          <p:nvPr/>
        </p:nvSpPr>
        <p:spPr>
          <a:xfrm>
            <a:off x="3261240" y="73137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176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"/>
          <p:cNvSpPr/>
          <p:nvPr/>
        </p:nvSpPr>
        <p:spPr>
          <a:xfrm>
            <a:off x="3912840" y="73137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1804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"/>
          <p:cNvSpPr/>
          <p:nvPr/>
        </p:nvSpPr>
        <p:spPr>
          <a:xfrm>
            <a:off x="3585600" y="7300800"/>
            <a:ext cx="4413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600" spc="-1" strike="noStrike">
                <a:solidFill>
                  <a:srgbClr val="ff0000"/>
                </a:solidFill>
                <a:latin typeface="Arial"/>
                <a:ea typeface="Arial"/>
              </a:rPr>
              <a:t>01782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"/>
          <p:cNvSpPr/>
          <p:nvPr/>
        </p:nvSpPr>
        <p:spPr>
          <a:xfrm>
            <a:off x="4316400" y="7405560"/>
            <a:ext cx="63360" cy="18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"/>
          <p:cNvSpPr/>
          <p:nvPr/>
        </p:nvSpPr>
        <p:spPr>
          <a:xfrm>
            <a:off x="690840" y="7529400"/>
            <a:ext cx="671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Klwa.s4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"/>
          <p:cNvSpPr/>
          <p:nvPr/>
        </p:nvSpPr>
        <p:spPr>
          <a:xfrm>
            <a:off x="3989520" y="8031240"/>
            <a:ext cx="258480" cy="203040"/>
          </a:xfrm>
          <a:prstGeom prst="rightArrow">
            <a:avLst>
              <a:gd name="adj1" fmla="val 50000"/>
              <a:gd name="adj2" fmla="val 31826"/>
            </a:avLst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"/>
          <p:cNvSpPr/>
          <p:nvPr/>
        </p:nvSpPr>
        <p:spPr>
          <a:xfrm>
            <a:off x="3923280" y="80485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784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"/>
          <p:cNvSpPr/>
          <p:nvPr/>
        </p:nvSpPr>
        <p:spPr>
          <a:xfrm>
            <a:off x="690840" y="8275680"/>
            <a:ext cx="525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Klla0F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"/>
          <p:cNvSpPr/>
          <p:nvPr/>
        </p:nvSpPr>
        <p:spPr>
          <a:xfrm>
            <a:off x="1446120" y="8394840"/>
            <a:ext cx="28796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"/>
          <p:cNvSpPr/>
          <p:nvPr/>
        </p:nvSpPr>
        <p:spPr>
          <a:xfrm>
            <a:off x="2230560" y="8286840"/>
            <a:ext cx="258480" cy="203040"/>
          </a:xfrm>
          <a:prstGeom prst="rightArrow">
            <a:avLst>
              <a:gd name="adj1" fmla="val 50000"/>
              <a:gd name="adj2" fmla="val 31826"/>
            </a:avLst>
          </a:prstGeom>
          <a:solidFill>
            <a:srgbClr val="ff9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"/>
          <p:cNvSpPr/>
          <p:nvPr/>
        </p:nvSpPr>
        <p:spPr>
          <a:xfrm flipH="1">
            <a:off x="2938320" y="8286840"/>
            <a:ext cx="260640" cy="203040"/>
          </a:xfrm>
          <a:prstGeom prst="rightArrow">
            <a:avLst>
              <a:gd name="adj1" fmla="val 50000"/>
              <a:gd name="adj2" fmla="val 32092"/>
            </a:avLst>
          </a:prstGeom>
          <a:solidFill>
            <a:srgbClr val="ff66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"/>
          <p:cNvSpPr/>
          <p:nvPr/>
        </p:nvSpPr>
        <p:spPr>
          <a:xfrm flipH="1">
            <a:off x="3307680" y="828684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"/>
          <p:cNvSpPr/>
          <p:nvPr/>
        </p:nvSpPr>
        <p:spPr>
          <a:xfrm>
            <a:off x="3989520" y="8286840"/>
            <a:ext cx="258480" cy="203040"/>
          </a:xfrm>
          <a:prstGeom prst="rightArrow">
            <a:avLst>
              <a:gd name="adj1" fmla="val 50000"/>
              <a:gd name="adj2" fmla="val 31826"/>
            </a:avLst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"/>
          <p:cNvSpPr/>
          <p:nvPr/>
        </p:nvSpPr>
        <p:spPr>
          <a:xfrm>
            <a:off x="2163600" y="83041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2521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"/>
          <p:cNvSpPr/>
          <p:nvPr/>
        </p:nvSpPr>
        <p:spPr>
          <a:xfrm>
            <a:off x="3922560" y="83041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2527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"/>
          <p:cNvSpPr/>
          <p:nvPr/>
        </p:nvSpPr>
        <p:spPr>
          <a:xfrm>
            <a:off x="2875680" y="83041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25234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"/>
          <p:cNvSpPr/>
          <p:nvPr/>
        </p:nvSpPr>
        <p:spPr>
          <a:xfrm>
            <a:off x="3255120" y="83041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2525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"/>
          <p:cNvSpPr/>
          <p:nvPr/>
        </p:nvSpPr>
        <p:spPr>
          <a:xfrm>
            <a:off x="1446120" y="7648560"/>
            <a:ext cx="28796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"/>
          <p:cNvSpPr/>
          <p:nvPr/>
        </p:nvSpPr>
        <p:spPr>
          <a:xfrm flipH="1">
            <a:off x="2938320" y="7540560"/>
            <a:ext cx="260640" cy="203400"/>
          </a:xfrm>
          <a:prstGeom prst="rightArrow">
            <a:avLst>
              <a:gd name="adj1" fmla="val 50000"/>
              <a:gd name="adj2" fmla="val 32035"/>
            </a:avLst>
          </a:prstGeom>
          <a:solidFill>
            <a:srgbClr val="ff66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"/>
          <p:cNvSpPr/>
          <p:nvPr/>
        </p:nvSpPr>
        <p:spPr>
          <a:xfrm flipH="1">
            <a:off x="3307680" y="7540560"/>
            <a:ext cx="260280" cy="203400"/>
          </a:xfrm>
          <a:prstGeom prst="rightArrow">
            <a:avLst>
              <a:gd name="adj1" fmla="val 50000"/>
              <a:gd name="adj2" fmla="val 31991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"/>
          <p:cNvSpPr/>
          <p:nvPr/>
        </p:nvSpPr>
        <p:spPr>
          <a:xfrm>
            <a:off x="3989520" y="7540560"/>
            <a:ext cx="258480" cy="203400"/>
          </a:xfrm>
          <a:prstGeom prst="rightArrow">
            <a:avLst>
              <a:gd name="adj1" fmla="val 50000"/>
              <a:gd name="adj2" fmla="val 31770"/>
            </a:avLst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"/>
          <p:cNvSpPr/>
          <p:nvPr/>
        </p:nvSpPr>
        <p:spPr>
          <a:xfrm>
            <a:off x="3926520" y="7558200"/>
            <a:ext cx="356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799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"/>
          <p:cNvSpPr/>
          <p:nvPr/>
        </p:nvSpPr>
        <p:spPr>
          <a:xfrm>
            <a:off x="2889000" y="7558200"/>
            <a:ext cx="356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799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"/>
          <p:cNvSpPr/>
          <p:nvPr/>
        </p:nvSpPr>
        <p:spPr>
          <a:xfrm>
            <a:off x="3267720" y="7558200"/>
            <a:ext cx="356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799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"/>
          <p:cNvSpPr/>
          <p:nvPr/>
        </p:nvSpPr>
        <p:spPr>
          <a:xfrm>
            <a:off x="1446120" y="7159680"/>
            <a:ext cx="28796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"/>
          <p:cNvSpPr/>
          <p:nvPr/>
        </p:nvSpPr>
        <p:spPr>
          <a:xfrm>
            <a:off x="2230560" y="7064280"/>
            <a:ext cx="258480" cy="203400"/>
          </a:xfrm>
          <a:prstGeom prst="rightArrow">
            <a:avLst>
              <a:gd name="adj1" fmla="val 50000"/>
              <a:gd name="adj2" fmla="val 31770"/>
            </a:avLst>
          </a:prstGeom>
          <a:solidFill>
            <a:srgbClr val="ff9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"/>
          <p:cNvSpPr/>
          <p:nvPr/>
        </p:nvSpPr>
        <p:spPr>
          <a:xfrm flipH="1">
            <a:off x="2939400" y="7064280"/>
            <a:ext cx="260280" cy="203400"/>
          </a:xfrm>
          <a:prstGeom prst="rightArrow">
            <a:avLst>
              <a:gd name="adj1" fmla="val 50000"/>
              <a:gd name="adj2" fmla="val 31991"/>
            </a:avLst>
          </a:prstGeom>
          <a:solidFill>
            <a:srgbClr val="ff66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"/>
          <p:cNvSpPr/>
          <p:nvPr/>
        </p:nvSpPr>
        <p:spPr>
          <a:xfrm flipH="1">
            <a:off x="3307680" y="7064280"/>
            <a:ext cx="260280" cy="203400"/>
          </a:xfrm>
          <a:prstGeom prst="rightArrow">
            <a:avLst>
              <a:gd name="adj1" fmla="val 50000"/>
              <a:gd name="adj2" fmla="val 31991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"/>
          <p:cNvSpPr/>
          <p:nvPr/>
        </p:nvSpPr>
        <p:spPr>
          <a:xfrm>
            <a:off x="3990960" y="706428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"/>
          <p:cNvSpPr/>
          <p:nvPr/>
        </p:nvSpPr>
        <p:spPr>
          <a:xfrm>
            <a:off x="2164320" y="70819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41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"/>
          <p:cNvSpPr/>
          <p:nvPr/>
        </p:nvSpPr>
        <p:spPr>
          <a:xfrm>
            <a:off x="3915360" y="70819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49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"/>
          <p:cNvSpPr/>
          <p:nvPr/>
        </p:nvSpPr>
        <p:spPr>
          <a:xfrm>
            <a:off x="2877120" y="70819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454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"/>
          <p:cNvSpPr/>
          <p:nvPr/>
        </p:nvSpPr>
        <p:spPr>
          <a:xfrm>
            <a:off x="3256560" y="70819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47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"/>
          <p:cNvSpPr/>
          <p:nvPr/>
        </p:nvSpPr>
        <p:spPr>
          <a:xfrm>
            <a:off x="691920" y="8015400"/>
            <a:ext cx="575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Ergo0F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"/>
          <p:cNvSpPr/>
          <p:nvPr/>
        </p:nvSpPr>
        <p:spPr>
          <a:xfrm>
            <a:off x="2230560" y="8026560"/>
            <a:ext cx="258480" cy="203040"/>
          </a:xfrm>
          <a:prstGeom prst="rightArrow">
            <a:avLst>
              <a:gd name="adj1" fmla="val 50000"/>
              <a:gd name="adj2" fmla="val 31826"/>
            </a:avLst>
          </a:prstGeom>
          <a:solidFill>
            <a:srgbClr val="ff9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"/>
          <p:cNvSpPr/>
          <p:nvPr/>
        </p:nvSpPr>
        <p:spPr>
          <a:xfrm flipH="1">
            <a:off x="2939400" y="802656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ff66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"/>
          <p:cNvSpPr/>
          <p:nvPr/>
        </p:nvSpPr>
        <p:spPr>
          <a:xfrm flipH="1">
            <a:off x="3310920" y="802656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"/>
          <p:cNvSpPr/>
          <p:nvPr/>
        </p:nvSpPr>
        <p:spPr>
          <a:xfrm>
            <a:off x="2165760" y="804384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790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"/>
          <p:cNvSpPr/>
          <p:nvPr/>
        </p:nvSpPr>
        <p:spPr>
          <a:xfrm>
            <a:off x="2878560" y="804384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788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"/>
          <p:cNvSpPr/>
          <p:nvPr/>
        </p:nvSpPr>
        <p:spPr>
          <a:xfrm>
            <a:off x="3257280" y="804384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7864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"/>
          <p:cNvSpPr/>
          <p:nvPr/>
        </p:nvSpPr>
        <p:spPr>
          <a:xfrm>
            <a:off x="4316400" y="8388360"/>
            <a:ext cx="6336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"/>
          <p:cNvSpPr/>
          <p:nvPr/>
        </p:nvSpPr>
        <p:spPr>
          <a:xfrm>
            <a:off x="4316400" y="7157880"/>
            <a:ext cx="63360" cy="18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"/>
          <p:cNvSpPr/>
          <p:nvPr/>
        </p:nvSpPr>
        <p:spPr>
          <a:xfrm flipH="1">
            <a:off x="1379160" y="7648560"/>
            <a:ext cx="7308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"/>
          <p:cNvSpPr/>
          <p:nvPr/>
        </p:nvSpPr>
        <p:spPr>
          <a:xfrm>
            <a:off x="4311720" y="8132760"/>
            <a:ext cx="6336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"/>
          <p:cNvSpPr/>
          <p:nvPr/>
        </p:nvSpPr>
        <p:spPr>
          <a:xfrm>
            <a:off x="1908000" y="778824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4be35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"/>
          <p:cNvSpPr/>
          <p:nvPr/>
        </p:nvSpPr>
        <p:spPr>
          <a:xfrm>
            <a:off x="1909800" y="729756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4be35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"/>
          <p:cNvSpPr/>
          <p:nvPr/>
        </p:nvSpPr>
        <p:spPr>
          <a:xfrm>
            <a:off x="1908000" y="828828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4be35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"/>
          <p:cNvSpPr/>
          <p:nvPr/>
        </p:nvSpPr>
        <p:spPr>
          <a:xfrm>
            <a:off x="1909800" y="706608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4be35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"/>
          <p:cNvSpPr/>
          <p:nvPr/>
        </p:nvSpPr>
        <p:spPr>
          <a:xfrm>
            <a:off x="1911240" y="802800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4be35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"/>
          <p:cNvSpPr/>
          <p:nvPr/>
        </p:nvSpPr>
        <p:spPr>
          <a:xfrm>
            <a:off x="2560680" y="7061040"/>
            <a:ext cx="260280" cy="203400"/>
          </a:xfrm>
          <a:prstGeom prst="rightArrow">
            <a:avLst>
              <a:gd name="adj1" fmla="val 50000"/>
              <a:gd name="adj2" fmla="val 31991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"/>
          <p:cNvSpPr/>
          <p:nvPr/>
        </p:nvSpPr>
        <p:spPr>
          <a:xfrm>
            <a:off x="2485800" y="70786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43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"/>
          <p:cNvSpPr/>
          <p:nvPr/>
        </p:nvSpPr>
        <p:spPr>
          <a:xfrm flipH="1">
            <a:off x="1385640" y="7893000"/>
            <a:ext cx="73080" cy="18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"/>
          <p:cNvSpPr/>
          <p:nvPr/>
        </p:nvSpPr>
        <p:spPr>
          <a:xfrm>
            <a:off x="2554200" y="779148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"/>
          <p:cNvSpPr/>
          <p:nvPr/>
        </p:nvSpPr>
        <p:spPr>
          <a:xfrm>
            <a:off x="2479320" y="78087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124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"/>
          <p:cNvSpPr/>
          <p:nvPr/>
        </p:nvSpPr>
        <p:spPr>
          <a:xfrm>
            <a:off x="1834920" y="78058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16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"/>
          <p:cNvSpPr/>
          <p:nvPr/>
        </p:nvSpPr>
        <p:spPr>
          <a:xfrm>
            <a:off x="1831680" y="731520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167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"/>
          <p:cNvSpPr/>
          <p:nvPr/>
        </p:nvSpPr>
        <p:spPr>
          <a:xfrm>
            <a:off x="1834200" y="83059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2519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"/>
          <p:cNvSpPr/>
          <p:nvPr/>
        </p:nvSpPr>
        <p:spPr>
          <a:xfrm>
            <a:off x="1829520" y="70833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38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"/>
          <p:cNvSpPr/>
          <p:nvPr/>
        </p:nvSpPr>
        <p:spPr>
          <a:xfrm>
            <a:off x="1831680" y="80452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793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"/>
          <p:cNvSpPr/>
          <p:nvPr/>
        </p:nvSpPr>
        <p:spPr>
          <a:xfrm>
            <a:off x="1589040" y="779004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cccc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"/>
          <p:cNvSpPr/>
          <p:nvPr/>
        </p:nvSpPr>
        <p:spPr>
          <a:xfrm>
            <a:off x="1589040" y="829008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cccc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"/>
          <p:cNvSpPr/>
          <p:nvPr/>
        </p:nvSpPr>
        <p:spPr>
          <a:xfrm>
            <a:off x="1589040" y="754380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cccc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"/>
          <p:cNvSpPr/>
          <p:nvPr/>
        </p:nvSpPr>
        <p:spPr>
          <a:xfrm>
            <a:off x="1590840" y="7067520"/>
            <a:ext cx="258480" cy="203400"/>
          </a:xfrm>
          <a:prstGeom prst="rightArrow">
            <a:avLst>
              <a:gd name="adj1" fmla="val 50000"/>
              <a:gd name="adj2" fmla="val 31770"/>
            </a:avLst>
          </a:prstGeom>
          <a:solidFill>
            <a:srgbClr val="cccc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"/>
          <p:cNvSpPr/>
          <p:nvPr/>
        </p:nvSpPr>
        <p:spPr>
          <a:xfrm>
            <a:off x="1592280" y="802944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cccc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"/>
          <p:cNvSpPr/>
          <p:nvPr/>
        </p:nvSpPr>
        <p:spPr>
          <a:xfrm>
            <a:off x="1510920" y="78073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19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"/>
          <p:cNvSpPr/>
          <p:nvPr/>
        </p:nvSpPr>
        <p:spPr>
          <a:xfrm>
            <a:off x="1512000" y="83073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2516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"/>
          <p:cNvSpPr/>
          <p:nvPr/>
        </p:nvSpPr>
        <p:spPr>
          <a:xfrm>
            <a:off x="1524600" y="7567560"/>
            <a:ext cx="356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802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"/>
          <p:cNvSpPr/>
          <p:nvPr/>
        </p:nvSpPr>
        <p:spPr>
          <a:xfrm>
            <a:off x="1506960" y="70851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36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"/>
          <p:cNvSpPr/>
          <p:nvPr/>
        </p:nvSpPr>
        <p:spPr>
          <a:xfrm>
            <a:off x="1508760" y="80470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795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"/>
          <p:cNvSpPr/>
          <p:nvPr/>
        </p:nvSpPr>
        <p:spPr>
          <a:xfrm>
            <a:off x="2230560" y="7547040"/>
            <a:ext cx="258480" cy="203040"/>
          </a:xfrm>
          <a:prstGeom prst="rightArrow">
            <a:avLst>
              <a:gd name="adj1" fmla="val 50000"/>
              <a:gd name="adj2" fmla="val 31826"/>
            </a:avLst>
          </a:prstGeom>
          <a:solidFill>
            <a:srgbClr val="ff99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"/>
          <p:cNvSpPr/>
          <p:nvPr/>
        </p:nvSpPr>
        <p:spPr>
          <a:xfrm>
            <a:off x="2177640" y="7558200"/>
            <a:ext cx="356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800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"/>
          <p:cNvSpPr/>
          <p:nvPr/>
        </p:nvSpPr>
        <p:spPr>
          <a:xfrm>
            <a:off x="1908000" y="754056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4be35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"/>
          <p:cNvSpPr/>
          <p:nvPr/>
        </p:nvSpPr>
        <p:spPr>
          <a:xfrm>
            <a:off x="453240" y="384120"/>
            <a:ext cx="2414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"/>
          <p:cNvSpPr/>
          <p:nvPr/>
        </p:nvSpPr>
        <p:spPr>
          <a:xfrm>
            <a:off x="2406600" y="3594240"/>
            <a:ext cx="2863800" cy="501480"/>
          </a:xfrm>
          <a:prstGeom prst="rect">
            <a:avLst/>
          </a:prstGeom>
          <a:noFill/>
          <a:ln cap="rnd" w="1908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"/>
          <p:cNvSpPr/>
          <p:nvPr/>
        </p:nvSpPr>
        <p:spPr>
          <a:xfrm>
            <a:off x="5618160" y="3363840"/>
            <a:ext cx="260280" cy="203400"/>
          </a:xfrm>
          <a:prstGeom prst="rightArrow">
            <a:avLst>
              <a:gd name="adj1" fmla="val 50000"/>
              <a:gd name="adj2" fmla="val 31991"/>
            </a:avLst>
          </a:prstGeom>
          <a:solidFill>
            <a:srgbClr val="80e9fe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"/>
          <p:cNvSpPr/>
          <p:nvPr/>
        </p:nvSpPr>
        <p:spPr>
          <a:xfrm>
            <a:off x="5297400" y="336384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8bc5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"/>
          <p:cNvSpPr/>
          <p:nvPr/>
        </p:nvSpPr>
        <p:spPr>
          <a:xfrm>
            <a:off x="5228280" y="33814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486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"/>
          <p:cNvSpPr/>
          <p:nvPr/>
        </p:nvSpPr>
        <p:spPr>
          <a:xfrm>
            <a:off x="5537880" y="33814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4884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"/>
          <p:cNvSpPr/>
          <p:nvPr/>
        </p:nvSpPr>
        <p:spPr>
          <a:xfrm flipH="1">
            <a:off x="2079000" y="386712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8bc5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"/>
          <p:cNvSpPr/>
          <p:nvPr/>
        </p:nvSpPr>
        <p:spPr>
          <a:xfrm>
            <a:off x="2006280" y="38782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69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"/>
          <p:cNvSpPr/>
          <p:nvPr/>
        </p:nvSpPr>
        <p:spPr>
          <a:xfrm>
            <a:off x="5618160" y="311796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80e9fe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"/>
          <p:cNvSpPr/>
          <p:nvPr/>
        </p:nvSpPr>
        <p:spPr>
          <a:xfrm>
            <a:off x="5537880" y="313704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251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"/>
          <p:cNvSpPr/>
          <p:nvPr/>
        </p:nvSpPr>
        <p:spPr>
          <a:xfrm flipH="1">
            <a:off x="1777320" y="3867120"/>
            <a:ext cx="260280" cy="203400"/>
          </a:xfrm>
          <a:prstGeom prst="rightArrow">
            <a:avLst>
              <a:gd name="adj1" fmla="val 50000"/>
              <a:gd name="adj2" fmla="val 31991"/>
            </a:avLst>
          </a:prstGeom>
          <a:solidFill>
            <a:srgbClr val="80e9fe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"/>
          <p:cNvSpPr/>
          <p:nvPr/>
        </p:nvSpPr>
        <p:spPr>
          <a:xfrm>
            <a:off x="1711080" y="38797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71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"/>
          <p:cNvSpPr/>
          <p:nvPr/>
        </p:nvSpPr>
        <p:spPr>
          <a:xfrm flipH="1">
            <a:off x="2075040" y="3627360"/>
            <a:ext cx="258480" cy="203400"/>
          </a:xfrm>
          <a:prstGeom prst="rightArrow">
            <a:avLst>
              <a:gd name="adj1" fmla="val 50000"/>
              <a:gd name="adj2" fmla="val 31770"/>
            </a:avLst>
          </a:prstGeom>
          <a:solidFill>
            <a:srgbClr val="8bc5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"/>
          <p:cNvSpPr/>
          <p:nvPr/>
        </p:nvSpPr>
        <p:spPr>
          <a:xfrm>
            <a:off x="2022120" y="3645000"/>
            <a:ext cx="356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865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"/>
          <p:cNvSpPr/>
          <p:nvPr/>
        </p:nvSpPr>
        <p:spPr>
          <a:xfrm>
            <a:off x="5618160" y="451656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80e9fe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"/>
          <p:cNvSpPr/>
          <p:nvPr/>
        </p:nvSpPr>
        <p:spPr>
          <a:xfrm>
            <a:off x="5546520" y="45226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1804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"/>
          <p:cNvSpPr/>
          <p:nvPr/>
        </p:nvSpPr>
        <p:spPr>
          <a:xfrm>
            <a:off x="5238720" y="4241880"/>
            <a:ext cx="10224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"/>
          <p:cNvSpPr/>
          <p:nvPr/>
        </p:nvSpPr>
        <p:spPr>
          <a:xfrm>
            <a:off x="5618160" y="4143240"/>
            <a:ext cx="260280" cy="203400"/>
          </a:xfrm>
          <a:prstGeom prst="rightArrow">
            <a:avLst>
              <a:gd name="adj1" fmla="val 50000"/>
              <a:gd name="adj2" fmla="val 31991"/>
            </a:avLst>
          </a:prstGeom>
          <a:solidFill>
            <a:srgbClr val="80e9fe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"/>
          <p:cNvSpPr/>
          <p:nvPr/>
        </p:nvSpPr>
        <p:spPr>
          <a:xfrm>
            <a:off x="5541120" y="41497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392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"/>
          <p:cNvSpPr/>
          <p:nvPr/>
        </p:nvSpPr>
        <p:spPr>
          <a:xfrm>
            <a:off x="4623480" y="4122720"/>
            <a:ext cx="587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Ergo0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"/>
          <p:cNvSpPr/>
          <p:nvPr/>
        </p:nvSpPr>
        <p:spPr>
          <a:xfrm>
            <a:off x="5297400" y="414036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8bc5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"/>
          <p:cNvSpPr/>
          <p:nvPr/>
        </p:nvSpPr>
        <p:spPr>
          <a:xfrm>
            <a:off x="5218560" y="41511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3948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"/>
          <p:cNvSpPr/>
          <p:nvPr/>
        </p:nvSpPr>
        <p:spPr>
          <a:xfrm>
            <a:off x="5951520" y="336564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cc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"/>
          <p:cNvSpPr/>
          <p:nvPr/>
        </p:nvSpPr>
        <p:spPr>
          <a:xfrm>
            <a:off x="5951520" y="3119400"/>
            <a:ext cx="260280" cy="203400"/>
          </a:xfrm>
          <a:prstGeom prst="rightArrow">
            <a:avLst>
              <a:gd name="adj1" fmla="val 50000"/>
              <a:gd name="adj2" fmla="val 31991"/>
            </a:avLst>
          </a:prstGeom>
          <a:solidFill>
            <a:srgbClr val="cc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"/>
          <p:cNvSpPr/>
          <p:nvPr/>
        </p:nvSpPr>
        <p:spPr>
          <a:xfrm>
            <a:off x="5951520" y="4518000"/>
            <a:ext cx="260280" cy="203400"/>
          </a:xfrm>
          <a:prstGeom prst="rightArrow">
            <a:avLst>
              <a:gd name="adj1" fmla="val 50000"/>
              <a:gd name="adj2" fmla="val 31991"/>
            </a:avLst>
          </a:prstGeom>
          <a:solidFill>
            <a:srgbClr val="cc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"/>
          <p:cNvSpPr/>
          <p:nvPr/>
        </p:nvSpPr>
        <p:spPr>
          <a:xfrm>
            <a:off x="5951520" y="4145040"/>
            <a:ext cx="260280" cy="203040"/>
          </a:xfrm>
          <a:prstGeom prst="rightArrow">
            <a:avLst>
              <a:gd name="adj1" fmla="val 50000"/>
              <a:gd name="adj2" fmla="val 32048"/>
            </a:avLst>
          </a:prstGeom>
          <a:solidFill>
            <a:srgbClr val="cc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3" name=""/>
          <p:cNvSpPr/>
          <p:nvPr/>
        </p:nvSpPr>
        <p:spPr>
          <a:xfrm flipH="1">
            <a:off x="1455120" y="3871800"/>
            <a:ext cx="258840" cy="203400"/>
          </a:xfrm>
          <a:prstGeom prst="rightArrow">
            <a:avLst>
              <a:gd name="adj1" fmla="val 50000"/>
              <a:gd name="adj2" fmla="val 31814"/>
            </a:avLst>
          </a:prstGeom>
          <a:solidFill>
            <a:srgbClr val="cc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"/>
          <p:cNvSpPr/>
          <p:nvPr/>
        </p:nvSpPr>
        <p:spPr>
          <a:xfrm flipH="1">
            <a:off x="1455120" y="362592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cc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"/>
          <p:cNvSpPr/>
          <p:nvPr/>
        </p:nvSpPr>
        <p:spPr>
          <a:xfrm flipH="1">
            <a:off x="1320480" y="3970440"/>
            <a:ext cx="7308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"/>
          <p:cNvSpPr/>
          <p:nvPr/>
        </p:nvSpPr>
        <p:spPr>
          <a:xfrm>
            <a:off x="5868720" y="337644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490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"/>
          <p:cNvSpPr/>
          <p:nvPr/>
        </p:nvSpPr>
        <p:spPr>
          <a:xfrm>
            <a:off x="5868720" y="313200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254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8" name=""/>
          <p:cNvSpPr/>
          <p:nvPr/>
        </p:nvSpPr>
        <p:spPr>
          <a:xfrm>
            <a:off x="5877360" y="45244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1782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"/>
          <p:cNvSpPr/>
          <p:nvPr/>
        </p:nvSpPr>
        <p:spPr>
          <a:xfrm>
            <a:off x="5865480" y="415116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3904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0" name=""/>
          <p:cNvSpPr/>
          <p:nvPr/>
        </p:nvSpPr>
        <p:spPr>
          <a:xfrm flipH="1">
            <a:off x="5157360" y="4243320"/>
            <a:ext cx="73080" cy="18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1" name=""/>
          <p:cNvSpPr/>
          <p:nvPr/>
        </p:nvSpPr>
        <p:spPr>
          <a:xfrm>
            <a:off x="1387800" y="388152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3740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2" name=""/>
          <p:cNvSpPr/>
          <p:nvPr/>
        </p:nvSpPr>
        <p:spPr>
          <a:xfrm>
            <a:off x="1401480" y="3639960"/>
            <a:ext cx="356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864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3" name=""/>
          <p:cNvSpPr/>
          <p:nvPr/>
        </p:nvSpPr>
        <p:spPr>
          <a:xfrm>
            <a:off x="5299200" y="3117960"/>
            <a:ext cx="258480" cy="203040"/>
          </a:xfrm>
          <a:prstGeom prst="rightArrow">
            <a:avLst>
              <a:gd name="adj1" fmla="val 50000"/>
              <a:gd name="adj2" fmla="val 31826"/>
            </a:avLst>
          </a:prstGeom>
          <a:solidFill>
            <a:srgbClr val="8bc5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4" name=""/>
          <p:cNvSpPr/>
          <p:nvPr/>
        </p:nvSpPr>
        <p:spPr>
          <a:xfrm>
            <a:off x="5215680" y="313200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1249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5" name=""/>
          <p:cNvSpPr/>
          <p:nvPr/>
        </p:nvSpPr>
        <p:spPr>
          <a:xfrm>
            <a:off x="5297400" y="4516560"/>
            <a:ext cx="258840" cy="203040"/>
          </a:xfrm>
          <a:prstGeom prst="rightArrow">
            <a:avLst>
              <a:gd name="adj1" fmla="val 50000"/>
              <a:gd name="adj2" fmla="val 31871"/>
            </a:avLst>
          </a:prstGeom>
          <a:solidFill>
            <a:srgbClr val="8bc5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81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6" name=""/>
          <p:cNvSpPr/>
          <p:nvPr/>
        </p:nvSpPr>
        <p:spPr>
          <a:xfrm>
            <a:off x="5223600" y="4524480"/>
            <a:ext cx="395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500" spc="-1" strike="noStrike">
                <a:solidFill>
                  <a:srgbClr val="000000"/>
                </a:solidFill>
                <a:latin typeface="Arial"/>
                <a:ea typeface="Arial"/>
              </a:rPr>
              <a:t>01826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Serge</dc:creator>
  <dc:description/>
  <dc:language>en-US</dc:language>
  <cp:lastModifiedBy>Cécile Neuvéglise</cp:lastModifiedBy>
  <cp:revision>0</cp:revision>
  <dc:subject/>
  <dc:title>Diapositive 1</dc:title>
</cp:coreProperties>
</file>